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21600000">
            <a:off x="2206015" y="2510155"/>
            <a:ext cx="7780020" cy="2668270"/>
            <a:chOff x="-12700" y="-449580"/>
            <a:chExt cx="7780020" cy="266827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 rot="21600000">
              <a:off x="0" y="-449580"/>
              <a:ext cx="7754620" cy="2668270"/>
            </a:xfrm>
            <a:prstGeom prst="rect">
              <a:avLst/>
            </a:prstGeom>
          </p:spPr>
        </p:pic>
        <p:sp>
          <p:nvSpPr>
            <p:cNvPr id="4" name="textbox 4"/>
            <p:cNvSpPr/>
            <p:nvPr/>
          </p:nvSpPr>
          <p:spPr>
            <a:xfrm>
              <a:off x="-12700" y="-306070"/>
              <a:ext cx="7780020" cy="2367280"/>
            </a:xfrm>
            <a:prstGeom prst="rect">
              <a:avLst/>
            </a:prstGeom>
            <a:noFill/>
            <a:ln w="0" cap="flat">
              <a:noFill/>
              <a:prstDash val="solid"/>
              <a:miter lim="0"/>
            </a:ln>
          </p:spPr>
          <p:txBody>
            <a:bodyPr vert="horz" wrap="square" lIns="0" tIns="0" rIns="0" bIns="0"/>
            <a:lstStyle/>
            <a:p>
              <a:pPr marL="2743200" lvl="6" indent="457200" algn="l" rtl="0" eaLnBrk="0" fontAlgn="auto">
                <a:lnSpc>
                  <a:spcPct val="100000"/>
                </a:lnSpc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Excluded (n=79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algn="l" rtl="0" eaLnBrk="0" fontAlgn="auto">
                <a:lnSpc>
                  <a:spcPct val="100000"/>
                </a:lnSpc>
                <a:spcBef>
                  <a:spcPts val="310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• Non-traumatic spinal cord injuries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48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indent="457200" algn="l" rtl="0" eaLnBrk="0" fontAlgn="auto">
                <a:lnSpc>
                  <a:spcPct val="100000"/>
                </a:lnSpc>
                <a:spcBef>
                  <a:spcPts val="310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  <a:sym typeface="+mn-ea"/>
                </a:rPr>
                <a:t>• 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Disc herniation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36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indent="457200" algn="l" rtl="0" eaLnBrk="0" fontAlgn="auto">
                <a:lnSpc>
                  <a:spcPct val="100000"/>
                </a:lnSpc>
                <a:spcBef>
                  <a:spcPts val="310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  <a:sym typeface="+mn-ea"/>
                </a:rPr>
                <a:t>• 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Myelitis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5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indent="457200" algn="l" rtl="0" eaLnBrk="0" fontAlgn="auto">
                <a:lnSpc>
                  <a:spcPct val="100000"/>
                </a:lnSpc>
                <a:spcBef>
                  <a:spcPts val="310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  <a:sym typeface="+mn-ea"/>
                </a:rPr>
                <a:t>• 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Intraspinal masses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7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algn="l" rtl="0" eaLnBrk="0" fontAlgn="auto">
                <a:lnSpc>
                  <a:spcPct val="100000"/>
                </a:lnSpc>
                <a:spcBef>
                  <a:spcPts val="205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• Vertebral fractures without spinal cord involvement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18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algn="l" rtl="0" eaLnBrk="0" fontAlgn="auto">
                <a:lnSpc>
                  <a:spcPct val="100000"/>
                </a:lnSpc>
                <a:spcBef>
                  <a:spcPts val="205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• Incomplete clinical records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9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  <a:p>
              <a:pPr marL="1602105" algn="l" rtl="0" eaLnBrk="0" fontAlgn="auto">
                <a:lnSpc>
                  <a:spcPct val="100000"/>
                </a:lnSpc>
                <a:spcBef>
                  <a:spcPts val="205"/>
                </a:spcBef>
                <a:buClrTx/>
                <a:buSzTx/>
                <a:buFontTx/>
              </a:pP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• Unclear diagnoses, 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(</a:t>
              </a:r>
              <a:r>
                <a:rPr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n = 4</a:t>
              </a:r>
              <a:r>
                <a:rPr lang="en-US" sz="1700" kern="0" spc="40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/>
                  <a:ea typeface="Times New Roman" panose="02020603050405020304"/>
                  <a:cs typeface="Times New Roman" panose="02020603050405020304"/>
                </a:rPr>
                <a:t>)</a:t>
              </a:r>
              <a:endParaRPr lang="en-US"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endParaRPr>
            </a:p>
          </p:txBody>
        </p:sp>
      </p:grpSp>
      <p:sp>
        <p:nvSpPr>
          <p:cNvPr id="6" name="textbox 6"/>
          <p:cNvSpPr/>
          <p:nvPr/>
        </p:nvSpPr>
        <p:spPr>
          <a:xfrm>
            <a:off x="2886075" y="977900"/>
            <a:ext cx="6420484" cy="857250"/>
          </a:xfrm>
          <a:prstGeom prst="rect">
            <a:avLst/>
          </a:prstGeom>
          <a:solidFill>
            <a:srgbClr val="B6C7EA">
              <a:alpha val="100000"/>
            </a:srgbClr>
          </a:solidFill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1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602105" indent="0" algn="l" rtl="0" eaLnBrk="0" fontAlgn="auto">
              <a:lnSpc>
                <a:spcPct val="100000"/>
              </a:lnSpc>
            </a:pPr>
            <a:r>
              <a: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Records assessed </a:t>
            </a:r>
            <a:r>
              <a:rPr sz="1700" kern="0" spc="3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for</a:t>
            </a:r>
            <a:r>
              <a:rPr sz="1700" kern="0" spc="7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3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eligibility</a:t>
            </a:r>
            <a:endParaRPr sz="17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marL="2549525" indent="0" algn="l" rtl="0" eaLnBrk="0" fontAlgn="auto">
              <a:lnSpc>
                <a:spcPct val="100000"/>
              </a:lnSpc>
            </a:pPr>
            <a:r>
              <a:rPr sz="1700" kern="0" spc="1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(n =</a:t>
            </a:r>
            <a:r>
              <a:rPr sz="1700" kern="0" spc="2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1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1213)</a:t>
            </a:r>
            <a:endParaRPr sz="17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</p:txBody>
      </p:sp>
      <p:sp>
        <p:nvSpPr>
          <p:cNvPr id="8" name="textbox 8"/>
          <p:cNvSpPr/>
          <p:nvPr/>
        </p:nvSpPr>
        <p:spPr>
          <a:xfrm>
            <a:off x="2802255" y="5841365"/>
            <a:ext cx="6420484" cy="855980"/>
          </a:xfrm>
          <a:prstGeom prst="rect">
            <a:avLst/>
          </a:prstGeom>
          <a:solidFill>
            <a:srgbClr val="B5C6E9">
              <a:alpha val="100000"/>
            </a:srgbClr>
          </a:solidFill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52000"/>
              </a:lnSpc>
            </a:pP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7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94840" indent="0" algn="l" rtl="0" eaLnBrk="0" fontAlgn="auto">
              <a:lnSpc>
                <a:spcPct val="100000"/>
              </a:lnSpc>
            </a:pPr>
            <a:r>
              <a: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Included in </a:t>
            </a:r>
            <a:r>
              <a:rPr sz="1700" kern="0" spc="3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the final</a:t>
            </a:r>
            <a:r>
              <a:rPr sz="1700" kern="0" spc="9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3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analysis</a:t>
            </a:r>
            <a:endParaRPr sz="17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  <a:p>
            <a:pPr marL="2740025" indent="0" algn="l" rtl="0" eaLnBrk="0" fontAlgn="auto">
              <a:lnSpc>
                <a:spcPct val="100000"/>
              </a:lnSpc>
            </a:pPr>
            <a:r>
              <a:rPr sz="1700" kern="0" spc="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(n =</a:t>
            </a:r>
            <a:r>
              <a:rPr sz="1700" kern="0" spc="26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1134)</a:t>
            </a:r>
            <a:endParaRPr sz="17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</p:txBody>
      </p:sp>
      <p:sp>
        <p:nvSpPr>
          <p:cNvPr id="10" name="textbox 10"/>
          <p:cNvSpPr/>
          <p:nvPr/>
        </p:nvSpPr>
        <p:spPr>
          <a:xfrm>
            <a:off x="2461056" y="378815"/>
            <a:ext cx="7237730" cy="23875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7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2000"/>
              </a:lnSpc>
            </a:pPr>
            <a:r>
              <a: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Supplementary Figure</a:t>
            </a:r>
            <a:r>
              <a:rPr sz="1700" kern="0" spc="17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S1. Flow diagram of</a:t>
            </a:r>
            <a:r>
              <a:rPr sz="1700" kern="0" spc="-16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 </a:t>
            </a:r>
            <a:r>
              <a:rPr sz="1700" kern="0" spc="40" dirty="0">
                <a:solidFill>
                  <a:srgbClr val="000000">
                    <a:alpha val="100000"/>
                  </a:srgbClr>
                </a:solidFill>
                <a:latin typeface="Times New Roman" panose="02020603050405020304"/>
                <a:ea typeface="Times New Roman" panose="02020603050405020304"/>
                <a:cs typeface="Times New Roman" panose="02020603050405020304"/>
              </a:rPr>
              <a:t>participant inclusion and exclusion</a:t>
            </a:r>
            <a:endParaRPr sz="1700" dirty="0">
              <a:latin typeface="Times New Roman" panose="02020603050405020304"/>
              <a:ea typeface="Times New Roman" panose="02020603050405020304"/>
              <a:cs typeface="Times New Roman" panose="02020603050405020304"/>
            </a:endParaRPr>
          </a:p>
        </p:txBody>
      </p:sp>
      <p:pic>
        <p:nvPicPr>
          <p:cNvPr id="12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5847080" y="5210810"/>
            <a:ext cx="498475" cy="630555"/>
          </a:xfrm>
          <a:prstGeom prst="rect">
            <a:avLst/>
          </a:prstGeom>
        </p:spPr>
      </p:pic>
      <p:pic>
        <p:nvPicPr>
          <p:cNvPr id="14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5847080" y="1851025"/>
            <a:ext cx="498475" cy="63055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6</Words>
  <Application>WPS 演示</Application>
  <PresentationFormat/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Arial</vt:lpstr>
      <vt:lpstr>微软雅黑</vt:lpstr>
      <vt:lpstr>Arial Unicode MS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刘雅楠</cp:lastModifiedBy>
  <cp:revision>2</cp:revision>
  <dcterms:created xsi:type="dcterms:W3CDTF">2026-04-28T12:45:00Z</dcterms:created>
  <dcterms:modified xsi:type="dcterms:W3CDTF">2026-04-28T13:00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ExNQ</vt:lpwstr>
  </property>
  <property fmtid="{D5CDD505-2E9C-101B-9397-08002B2CF9AE}" pid="3" name="Created">
    <vt:filetime>2026-02-22T03:53:29Z</vt:filetime>
  </property>
  <property fmtid="{D5CDD505-2E9C-101B-9397-08002B2CF9AE}" pid="4" name="KSOProductBuildVer">
    <vt:lpwstr>2052-12.1.0.25225</vt:lpwstr>
  </property>
  <property fmtid="{D5CDD505-2E9C-101B-9397-08002B2CF9AE}" pid="5" name="ICV">
    <vt:lpwstr>28AEFD7A354B474DB62A1E498583011D_13</vt:lpwstr>
  </property>
</Properties>
</file>